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56" r:id="rId5"/>
    <p:sldId id="257" r:id="rId6"/>
    <p:sldId id="258" r:id="rId7"/>
    <p:sldId id="259" r:id="rId8"/>
    <p:sldId id="260" r:id="rId9"/>
    <p:sldId id="261" r:id="rId10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5"/>
    <p:restoredTop sz="94692"/>
  </p:normalViewPr>
  <p:slideViewPr>
    <p:cSldViewPr snapToGrid="0" snapToObjects="1">
      <p:cViewPr varScale="1">
        <p:scale>
          <a:sx n="109" d="100"/>
          <a:sy n="109" d="100"/>
        </p:scale>
        <p:origin x="14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903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009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108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482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405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01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684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563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809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056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355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DF3919-E894-514D-9DCE-11068EBB42BB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7D264-A35A-6843-9475-D14EE9F62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602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3363657D-3C90-2A44-8CCB-426767A45A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2708" y="718161"/>
            <a:ext cx="8816253" cy="502321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E01D27D-AFA9-3E4D-BFFD-BC63BC27E023}"/>
              </a:ext>
            </a:extLst>
          </p:cNvPr>
          <p:cNvSpPr txBox="1"/>
          <p:nvPr/>
        </p:nvSpPr>
        <p:spPr>
          <a:xfrm>
            <a:off x="562708" y="5917183"/>
            <a:ext cx="1009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ome screen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54193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0359AB2-7F79-9C44-A02A-A35DD13A1F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0877" y="160496"/>
            <a:ext cx="5961185" cy="617634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19D9C32-60A3-6047-8D71-E4C2C8440FBE}"/>
              </a:ext>
            </a:extLst>
          </p:cNvPr>
          <p:cNvSpPr txBox="1"/>
          <p:nvPr/>
        </p:nvSpPr>
        <p:spPr>
          <a:xfrm>
            <a:off x="1644163" y="6449838"/>
            <a:ext cx="1241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herapy sessions</a:t>
            </a:r>
          </a:p>
        </p:txBody>
      </p:sp>
    </p:spTree>
    <p:extLst>
      <p:ext uri="{BB962C8B-B14F-4D97-AF65-F5344CB8AC3E}">
        <p14:creationId xmlns:p14="http://schemas.microsoft.com/office/powerpoint/2010/main" val="1951447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AB8D0FB-8F4C-CC4A-A595-B04E4D9A37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4355" y="334674"/>
            <a:ext cx="6066730" cy="59879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C7579C2-CC44-C149-A91E-3A1C39E62582}"/>
              </a:ext>
            </a:extLst>
          </p:cNvPr>
          <p:cNvSpPr txBox="1"/>
          <p:nvPr/>
        </p:nvSpPr>
        <p:spPr>
          <a:xfrm>
            <a:off x="1424355" y="6406305"/>
            <a:ext cx="1187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odule content</a:t>
            </a:r>
          </a:p>
        </p:txBody>
      </p:sp>
    </p:spTree>
    <p:extLst>
      <p:ext uri="{BB962C8B-B14F-4D97-AF65-F5344CB8AC3E}">
        <p14:creationId xmlns:p14="http://schemas.microsoft.com/office/powerpoint/2010/main" val="1145487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D133295-4DD0-AD47-8B31-F1076A79B3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6915" y="184924"/>
            <a:ext cx="5477608" cy="601528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91FA800-BD74-D14C-8C80-E96265EDFF06}"/>
              </a:ext>
            </a:extLst>
          </p:cNvPr>
          <p:cNvSpPr txBox="1"/>
          <p:nvPr/>
        </p:nvSpPr>
        <p:spPr>
          <a:xfrm>
            <a:off x="1601376" y="6338710"/>
            <a:ext cx="1605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ideos </a:t>
            </a:r>
            <a:r>
              <a:rPr lang="en-US" sz="1200" dirty="0" smtClean="0"/>
              <a:t>and </a:t>
            </a:r>
            <a:r>
              <a:rPr lang="en-US" sz="1200" dirty="0"/>
              <a:t>animations</a:t>
            </a:r>
          </a:p>
        </p:txBody>
      </p:sp>
    </p:spTree>
    <p:extLst>
      <p:ext uri="{BB962C8B-B14F-4D97-AF65-F5344CB8AC3E}">
        <p14:creationId xmlns:p14="http://schemas.microsoft.com/office/powerpoint/2010/main" val="37974389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CBF9AB1-808C-1C4C-8FC3-76E9D9E3A7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6915" y="307731"/>
            <a:ext cx="6061962" cy="597011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890573E-7D31-E343-A378-84A56613049C}"/>
              </a:ext>
            </a:extLst>
          </p:cNvPr>
          <p:cNvSpPr txBox="1"/>
          <p:nvPr/>
        </p:nvSpPr>
        <p:spPr>
          <a:xfrm>
            <a:off x="1696915" y="6388140"/>
            <a:ext cx="9245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Worksheets</a:t>
            </a:r>
          </a:p>
        </p:txBody>
      </p:sp>
    </p:spTree>
    <p:extLst>
      <p:ext uri="{BB962C8B-B14F-4D97-AF65-F5344CB8AC3E}">
        <p14:creationId xmlns:p14="http://schemas.microsoft.com/office/powerpoint/2010/main" val="21602695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187C8BA-4A9E-C34A-BF4E-F8075A04A1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3256" y="182505"/>
            <a:ext cx="5537982" cy="62011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E202E7C-11B9-D149-9974-7CC98487FCDE}"/>
              </a:ext>
            </a:extLst>
          </p:cNvPr>
          <p:cNvSpPr txBox="1"/>
          <p:nvPr/>
        </p:nvSpPr>
        <p:spPr>
          <a:xfrm>
            <a:off x="1644163" y="6392875"/>
            <a:ext cx="1968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outine outcome measur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52758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79D796877130D4DB5E09A034F5071BD" ma:contentTypeVersion="13" ma:contentTypeDescription="Create a new document." ma:contentTypeScope="" ma:versionID="feee430570f47a2e9a757e335f650e52">
  <xsd:schema xmlns:xsd="http://www.w3.org/2001/XMLSchema" xmlns:xs="http://www.w3.org/2001/XMLSchema" xmlns:p="http://schemas.microsoft.com/office/2006/metadata/properties" xmlns:ns3="033e7d77-0493-452f-88e4-9522cce98248" xmlns:ns4="41d2de59-5231-46e2-a7a7-6b8cee87d748" targetNamespace="http://schemas.microsoft.com/office/2006/metadata/properties" ma:root="true" ma:fieldsID="bfae8a74e82c7d10d714259ff62f8560" ns3:_="" ns4:_="">
    <xsd:import namespace="033e7d77-0493-452f-88e4-9522cce98248"/>
    <xsd:import namespace="41d2de59-5231-46e2-a7a7-6b8cee87d74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3e7d77-0493-452f-88e4-9522cce9824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d2de59-5231-46e2-a7a7-6b8cee87d748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57F66C9-5276-4BE8-9E67-E1E759E372E4}">
  <ds:schemaRefs>
    <ds:schemaRef ds:uri="http://purl.org/dc/terms/"/>
    <ds:schemaRef ds:uri="033e7d77-0493-452f-88e4-9522cce98248"/>
    <ds:schemaRef ds:uri="http://schemas.microsoft.com/office/2006/metadata/properties"/>
    <ds:schemaRef ds:uri="http://schemas.microsoft.com/office/2006/documentManagement/types"/>
    <ds:schemaRef ds:uri="http://purl.org/dc/elements/1.1/"/>
    <ds:schemaRef ds:uri="http://schemas.openxmlformats.org/package/2006/metadata/core-properties"/>
    <ds:schemaRef ds:uri="http://schemas.microsoft.com/office/infopath/2007/PartnerControls"/>
    <ds:schemaRef ds:uri="41d2de59-5231-46e2-a7a7-6b8cee87d748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00E944A-06FD-494D-8FF0-440E1E761CA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7A1E8F0-F7E0-466F-8FF3-5A2FF1BCD86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3e7d77-0493-452f-88e4-9522cce98248"/>
    <ds:schemaRef ds:uri="41d2de59-5231-46e2-a7a7-6b8cee87d74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13</Words>
  <Application>Microsoft Office PowerPoint</Application>
  <PresentationFormat>A4 Paper (210x297 mm)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Winchester</dc:creator>
  <cp:lastModifiedBy>Tessa Reardon</cp:lastModifiedBy>
  <cp:revision>13</cp:revision>
  <cp:lastPrinted>2021-01-19T08:06:24Z</cp:lastPrinted>
  <dcterms:created xsi:type="dcterms:W3CDTF">2021-01-12T17:49:01Z</dcterms:created>
  <dcterms:modified xsi:type="dcterms:W3CDTF">2022-04-07T05:3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79D796877130D4DB5E09A034F5071BD</vt:lpwstr>
  </property>
</Properties>
</file>